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65" r:id="rId4"/>
    <p:sldId id="264" r:id="rId5"/>
    <p:sldId id="266" r:id="rId6"/>
  </p:sldIdLst>
  <p:sldSz cx="18000663" cy="14400213"/>
  <p:notesSz cx="6858000" cy="9144000"/>
  <p:defaultTextStyle>
    <a:defPPr>
      <a:defRPr lang="es-MX"/>
    </a:defPPr>
    <a:lvl1pPr marL="0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1pPr>
    <a:lvl2pPr marL="925739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2pPr>
    <a:lvl3pPr marL="1851477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3pPr>
    <a:lvl4pPr marL="2777216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4pPr>
    <a:lvl5pPr marL="3702954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5pPr>
    <a:lvl6pPr marL="4628693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6pPr>
    <a:lvl7pPr marL="5554431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7pPr>
    <a:lvl8pPr marL="6480170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8pPr>
    <a:lvl9pPr marL="7405908" algn="l" defTabSz="1851477" rtl="0" eaLnBrk="1" latinLnBrk="0" hangingPunct="1">
      <a:defRPr sz="364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  <a:srgbClr val="66CCFF"/>
    <a:srgbClr val="66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1" d="100"/>
          <a:sy n="41" d="100"/>
        </p:scale>
        <p:origin x="146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895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725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229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377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31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080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612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88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122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918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039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17B06-8B5C-48C9-92D0-4838182491C1}" type="datetimeFigureOut">
              <a:rPr lang="en-US" smtClean="0"/>
              <a:t>4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6EC18-1F3F-4FBD-BFB0-8A7CBABDE1A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308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350049" y="2459421"/>
            <a:ext cx="15300564" cy="3397200"/>
          </a:xfrm>
        </p:spPr>
        <p:txBody>
          <a:bodyPr>
            <a:noAutofit/>
          </a:bodyPr>
          <a:lstStyle/>
          <a:p>
            <a:r>
              <a:rPr lang="en-US" sz="4800" b="1" dirty="0"/>
              <a:t>Metal borohydrides beyond group I and II, a </a:t>
            </a:r>
            <a:r>
              <a:rPr lang="en-US" sz="4800" b="1" dirty="0" smtClean="0"/>
              <a:t>review</a:t>
            </a:r>
            <a:br>
              <a:rPr lang="en-US" sz="4800" b="1" dirty="0" smtClean="0"/>
            </a:br>
            <a:r>
              <a:rPr lang="en-US" sz="4800" b="1" dirty="0" smtClean="0"/>
              <a:t>(supplementary material</a:t>
            </a:r>
            <a:r>
              <a:rPr lang="en-US" sz="4800" b="1" dirty="0" smtClean="0"/>
              <a:t>)</a:t>
            </a:r>
            <a:br>
              <a:rPr lang="en-US" sz="4800" b="1" dirty="0" smtClean="0"/>
            </a:br>
            <a:r>
              <a:rPr lang="en-US" sz="4800" b="1" dirty="0" smtClean="0"/>
              <a:t>Editable ¨periodic tables¨</a:t>
            </a:r>
            <a:r>
              <a:rPr lang="en-US" sz="4800" b="1" dirty="0" smtClean="0"/>
              <a:t/>
            </a:r>
            <a:br>
              <a:rPr lang="en-US" sz="4800" b="1" dirty="0" smtClean="0"/>
            </a:br>
            <a:r>
              <a:rPr lang="es-MX" sz="4800" b="1" dirty="0"/>
              <a:t/>
            </a:r>
            <a:br>
              <a:rPr lang="es-MX" sz="4800" b="1" dirty="0"/>
            </a:br>
            <a:r>
              <a:rPr lang="es-MX" sz="4800" b="1" dirty="0"/>
              <a:t>Karina Suárez-Alcántara</a:t>
            </a:r>
            <a:r>
              <a:rPr lang="es-MX" sz="4800" b="1" baseline="30000" dirty="0"/>
              <a:t>1</a:t>
            </a:r>
            <a:r>
              <a:rPr lang="es-MX" sz="4800" b="1" dirty="0"/>
              <a:t>* and Juan Rogelio Tena García</a:t>
            </a:r>
            <a:r>
              <a:rPr lang="es-MX" sz="4800" b="1" baseline="30000" dirty="0"/>
              <a:t>1</a:t>
            </a:r>
            <a:r>
              <a:rPr lang="es-MX" sz="4800" b="1" dirty="0"/>
              <a:t> </a:t>
            </a:r>
            <a:endParaRPr lang="en-US" sz="4800" dirty="0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2250082" y="8257129"/>
            <a:ext cx="13500497" cy="3476717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Morelia Unit of Materials Institute Research, National Autonomous University of Mexico, 58190, Mexico. </a:t>
            </a:r>
            <a:r>
              <a:rPr lang="es-MX" dirty="0"/>
              <a:t>Antigua Carretera a Pátzcuaro No. 8701.Col. Ex Hacienda de San José de la Huerta C.P. 58190, Morelia, Michoacán, México.</a:t>
            </a:r>
          </a:p>
          <a:p>
            <a:r>
              <a:rPr lang="en-US" dirty="0"/>
              <a:t>*	Correspondence: karina_suarez@iim.unam.mx; Tel.: +52-55-5623-7300 ext. 37889</a:t>
            </a:r>
          </a:p>
        </p:txBody>
      </p:sp>
    </p:spTree>
    <p:extLst>
      <p:ext uri="{BB962C8B-B14F-4D97-AF65-F5344CB8AC3E}">
        <p14:creationId xmlns:p14="http://schemas.microsoft.com/office/powerpoint/2010/main" val="245431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9400040"/>
              </p:ext>
            </p:extLst>
          </p:nvPr>
        </p:nvGraphicFramePr>
        <p:xfrm>
          <a:off x="0" y="313509"/>
          <a:ext cx="17478106" cy="7623846"/>
        </p:xfrm>
        <a:graphic>
          <a:graphicData uri="http://schemas.openxmlformats.org/drawingml/2006/table">
            <a:tbl>
              <a:tblPr firstRow="1" firstCol="1" bandRow="1"/>
              <a:tblGrid>
                <a:gridCol w="563096"/>
                <a:gridCol w="1271277"/>
                <a:gridCol w="1221001"/>
                <a:gridCol w="1173726"/>
                <a:gridCol w="115879"/>
                <a:gridCol w="1160471"/>
                <a:gridCol w="174258"/>
                <a:gridCol w="1121142"/>
                <a:gridCol w="213587"/>
                <a:gridCol w="1119913"/>
                <a:gridCol w="1333500"/>
                <a:gridCol w="1257300"/>
                <a:gridCol w="323850"/>
                <a:gridCol w="355147"/>
                <a:gridCol w="1359981"/>
                <a:gridCol w="1371034"/>
                <a:gridCol w="1485838"/>
                <a:gridCol w="361950"/>
                <a:gridCol w="400050"/>
                <a:gridCol w="342900"/>
                <a:gridCol w="342900"/>
                <a:gridCol w="409306"/>
              </a:tblGrid>
              <a:tr h="5262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es-MX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262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6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713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51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(BH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8 </a:t>
                      </a:r>
                      <a:r>
                        <a:rPr lang="es-MX" sz="2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6 K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 gridSpan="7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b="1" noProof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1600" baseline="0" noProof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THF</a:t>
                      </a:r>
                      <a:r>
                        <a:rPr lang="en-US" sz="1600" noProof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noProof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* probably solvated,</a:t>
                      </a:r>
                      <a:r>
                        <a:rPr lang="en-US" sz="1600" baseline="0" noProof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no experimental crystal data</a:t>
                      </a:r>
                      <a:endParaRPr lang="en-US" sz="1600" noProof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b="1" baseline="0" noProof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ʞ</a:t>
                      </a:r>
                      <a:r>
                        <a:rPr lang="en-US" sz="1600" noProof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2THF and 3THF solvated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noProof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§ not isolated form other reaction products</a:t>
                      </a:r>
                      <a:endParaRPr lang="en-US" sz="1600" noProof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800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713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66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7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(BH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.9 </a:t>
                      </a:r>
                      <a:r>
                        <a:rPr lang="es-MX" sz="2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2 K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.91 </a:t>
                      </a:r>
                      <a:r>
                        <a:rPr lang="es-MX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0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3310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47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2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(BH</a:t>
                      </a:r>
                      <a:r>
                        <a:rPr lang="es-MX" sz="2000" b="1" kern="1200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kern="1200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56 </a:t>
                      </a:r>
                      <a:r>
                        <a:rPr lang="es-MX" sz="2000" b="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8 K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kern="1200" baseline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b="1" kern="1200" baseline="-25000" dirty="0" smtClean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.1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8-33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67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3-46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(BH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b="1" dirty="0" smtClean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87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3-298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(BH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53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3-43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43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3-27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14 </a:t>
                      </a:r>
                      <a:r>
                        <a:rPr lang="es-MX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1-273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n(BH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*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H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 </a:t>
                      </a:r>
                      <a:r>
                        <a:rPr lang="es-MX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8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6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7782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2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7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r(BH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7 </a:t>
                      </a:r>
                      <a:r>
                        <a:rPr lang="es-MX" sz="2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3 K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06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0 K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r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71 </a:t>
                      </a:r>
                      <a:r>
                        <a:rPr lang="es-MX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5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8 </a:t>
                      </a:r>
                      <a:r>
                        <a:rPr lang="es-MX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3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(BH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67 </a:t>
                      </a:r>
                      <a:r>
                        <a:rPr lang="en-US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8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(BH</a:t>
                      </a:r>
                      <a:r>
                        <a:rPr lang="en-US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baseline="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ʞ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6 </a:t>
                      </a:r>
                      <a:r>
                        <a:rPr lang="en-US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3 K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713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BH</a:t>
                      </a:r>
                      <a:r>
                        <a:rPr lang="en-US" sz="2000" b="1" baseline="-250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73 </a:t>
                      </a:r>
                      <a:r>
                        <a:rPr lang="en-US" sz="2000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95 K</a:t>
                      </a:r>
                      <a:endParaRPr lang="es-MX" sz="20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(BH</a:t>
                      </a:r>
                      <a:r>
                        <a:rPr lang="en-US" sz="20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20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20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2000" b="1" kern="1200" baseline="-250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83 </a:t>
                      </a:r>
                      <a:r>
                        <a:rPr lang="en-US" sz="20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kern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773 K</a:t>
                      </a:r>
                      <a:endParaRPr lang="es-MX" sz="200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kern="12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kern="1200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f</a:t>
                      </a:r>
                      <a:r>
                        <a:rPr lang="en-US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20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2000" b="1" baseline="-25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78 </a:t>
                      </a:r>
                      <a:r>
                        <a:rPr lang="en-US" sz="200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3 K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lBH</a:t>
                      </a:r>
                      <a:r>
                        <a:rPr lang="en-US" sz="2000" b="1" baseline="-2500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1" baseline="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§</a:t>
                      </a:r>
                      <a:endParaRPr lang="es-MX" sz="2000" baseline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b="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4 </a:t>
                      </a:r>
                      <a:r>
                        <a:rPr lang="en-US" sz="2000" b="0" dirty="0" err="1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2000" b="0" dirty="0" smtClean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20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3964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09" marR="67509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Berlin Sans FB" panose="020E0602020502020306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400" dirty="0">
                        <a:effectLst/>
                        <a:latin typeface="Berlin Sans FB" panose="020E0602020502020306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FF0000"/>
                          </a:solidFill>
                          <a:effectLst/>
                          <a:latin typeface="Berlin Sans FB" panose="020E0602020502020306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kern="1200" dirty="0">
                        <a:solidFill>
                          <a:srgbClr val="FF0000"/>
                        </a:solidFill>
                        <a:effectLst/>
                        <a:latin typeface="Berlin Sans FB" panose="020E0602020502020306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kern="1200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kern="1200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2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49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" name="Tab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6088697"/>
              </p:ext>
            </p:extLst>
          </p:nvPr>
        </p:nvGraphicFramePr>
        <p:xfrm>
          <a:off x="63519" y="8840696"/>
          <a:ext cx="17735965" cy="3221338"/>
        </p:xfrm>
        <a:graphic>
          <a:graphicData uri="http://schemas.openxmlformats.org/drawingml/2006/table">
            <a:tbl>
              <a:tblPr firstRow="1" firstCol="1" bandRow="1"/>
              <a:tblGrid>
                <a:gridCol w="1117581"/>
                <a:gridCol w="1181100"/>
                <a:gridCol w="1181100"/>
                <a:gridCol w="1314450"/>
                <a:gridCol w="1143000"/>
                <a:gridCol w="1181100"/>
                <a:gridCol w="1162050"/>
                <a:gridCol w="1143000"/>
                <a:gridCol w="1181100"/>
                <a:gridCol w="1143000"/>
                <a:gridCol w="1162050"/>
                <a:gridCol w="1143000"/>
                <a:gridCol w="1257300"/>
                <a:gridCol w="1295400"/>
                <a:gridCol w="1130734"/>
              </a:tblGrid>
              <a:tr h="11316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6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3-57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55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8-56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52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0-53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d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41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48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8 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21 </a:t>
                      </a:r>
                      <a:r>
                        <a:rPr lang="es-MX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u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44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8 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u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9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6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8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d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99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8-543 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b(BH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95 </a:t>
                      </a:r>
                      <a:r>
                        <a:rPr lang="es-MX" sz="19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523</a:t>
                      </a:r>
                      <a:r>
                        <a:rPr lang="es-MX" sz="19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K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9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y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4 </a:t>
                      </a:r>
                      <a:r>
                        <a:rPr lang="es-MX" sz="19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523</a:t>
                      </a:r>
                      <a:r>
                        <a:rPr lang="es-MX" sz="19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K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77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71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9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m(BH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71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9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523</a:t>
                      </a:r>
                      <a:r>
                        <a:rPr lang="es-MX" sz="19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K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b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6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8 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900" b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Yb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8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Lu(BH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4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</a:tr>
              <a:tr h="65004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3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a(BH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5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2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3- 423 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p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9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3 </a:t>
                      </a:r>
                      <a:r>
                        <a:rPr lang="en-US" sz="19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en-US" sz="19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9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K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9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9 </a:t>
                      </a:r>
                      <a:r>
                        <a:rPr lang="en-US" sz="19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3 K</a:t>
                      </a:r>
                      <a:endParaRPr lang="es-MX" sz="19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9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36000" marB="360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</a:tr>
            </a:tbl>
          </a:graphicData>
        </a:graphic>
      </p:graphicFrame>
      <p:cxnSp>
        <p:nvCxnSpPr>
          <p:cNvPr id="6" name="Conector recto 5"/>
          <p:cNvCxnSpPr/>
          <p:nvPr/>
        </p:nvCxnSpPr>
        <p:spPr>
          <a:xfrm flipH="1">
            <a:off x="0" y="7943850"/>
            <a:ext cx="3124200" cy="838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4248150" y="7943850"/>
            <a:ext cx="13506450" cy="81915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57888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9902924"/>
              </p:ext>
            </p:extLst>
          </p:nvPr>
        </p:nvGraphicFramePr>
        <p:xfrm>
          <a:off x="2" y="0"/>
          <a:ext cx="18000660" cy="7937547"/>
        </p:xfrm>
        <a:graphic>
          <a:graphicData uri="http://schemas.openxmlformats.org/drawingml/2006/table">
            <a:tbl>
              <a:tblPr firstRow="1" firstCol="1" bandRow="1"/>
              <a:tblGrid>
                <a:gridCol w="354623"/>
                <a:gridCol w="195796"/>
                <a:gridCol w="195796"/>
                <a:gridCol w="2237615"/>
                <a:gridCol w="1473868"/>
                <a:gridCol w="1409700"/>
                <a:gridCol w="1495926"/>
                <a:gridCol w="2009274"/>
                <a:gridCol w="1409700"/>
                <a:gridCol w="209550"/>
                <a:gridCol w="190500"/>
                <a:gridCol w="190500"/>
                <a:gridCol w="2487529"/>
                <a:gridCol w="1876926"/>
                <a:gridCol w="1445795"/>
                <a:gridCol w="247650"/>
                <a:gridCol w="209550"/>
                <a:gridCol w="239636"/>
                <a:gridCol w="120726"/>
              </a:tblGrid>
              <a:tr h="3786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86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048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1854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l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, Na, K, </a:t>
                      </a:r>
                      <a:r>
                        <a:rPr lang="en-US" sz="1800" b="0" baseline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s-MX" sz="800" b="1" baseline="-25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7125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c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,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, K,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Cs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b="1" baseline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V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·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DME</a:t>
                      </a: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Mn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Mn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nZ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800" b="1" kern="1200" baseline="-250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1-x)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800" b="1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, Na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**, K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* and SBA-15 stabilized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,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Na</a:t>
                      </a:r>
                      <a:endParaRPr lang="en-US" sz="1800" b="0" dirty="0" smtClean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Zn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b="1" kern="1200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en-US" sz="1800" b="1" kern="1200" baseline="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1-x)</a:t>
                      </a:r>
                      <a:r>
                        <a:rPr lang="en-US" sz="1800" b="1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n</a:t>
                      </a:r>
                      <a:r>
                        <a:rPr lang="en-US" sz="1800" b="1" kern="1200" baseline="-250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95713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,</a:t>
                      </a:r>
                      <a:r>
                        <a:rPr lang="es-MX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K, Rb </a:t>
                      </a:r>
                      <a:r>
                        <a:rPr lang="es-MX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Y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Zr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b="1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r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Cd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Cd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3984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Hf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Pb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048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620545" y="7241778"/>
            <a:ext cx="184731" cy="653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7132465"/>
              </p:ext>
            </p:extLst>
          </p:nvPr>
        </p:nvGraphicFramePr>
        <p:xfrm>
          <a:off x="209550" y="9023085"/>
          <a:ext cx="17657762" cy="1708498"/>
        </p:xfrm>
        <a:graphic>
          <a:graphicData uri="http://schemas.openxmlformats.org/drawingml/2006/table">
            <a:tbl>
              <a:tblPr firstRow="1" firstCol="1" bandRow="1"/>
              <a:tblGrid>
                <a:gridCol w="1924050"/>
                <a:gridCol w="1924050"/>
                <a:gridCol w="1447800"/>
                <a:gridCol w="228600"/>
                <a:gridCol w="228600"/>
                <a:gridCol w="1543050"/>
                <a:gridCol w="2095500"/>
                <a:gridCol w="2552700"/>
                <a:gridCol w="266700"/>
                <a:gridCol w="285750"/>
                <a:gridCol w="1276350"/>
                <a:gridCol w="1485900"/>
                <a:gridCol w="266700"/>
                <a:gridCol w="1566597"/>
                <a:gridCol w="565415"/>
              </a:tblGrid>
              <a:tr h="14150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La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Ce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Pr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m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800" b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=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,Rb,Cs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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DME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s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b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Gd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800" b="1" kern="1200" baseline="-250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d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+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A=K, Cs</a:t>
                      </a:r>
                      <a:endParaRPr lang="en-US" sz="1800" kern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Ho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Er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Li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a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K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</a:tr>
              <a:tr h="2729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</a:tr>
            </a:tbl>
          </a:graphicData>
        </a:graphic>
      </p:graphicFrame>
      <p:cxnSp>
        <p:nvCxnSpPr>
          <p:cNvPr id="13" name="Conector recto 12"/>
          <p:cNvCxnSpPr/>
          <p:nvPr/>
        </p:nvCxnSpPr>
        <p:spPr>
          <a:xfrm flipH="1">
            <a:off x="228600" y="8084220"/>
            <a:ext cx="495300" cy="8108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/>
          <p:cNvCxnSpPr/>
          <p:nvPr/>
        </p:nvCxnSpPr>
        <p:spPr>
          <a:xfrm>
            <a:off x="2952750" y="8084220"/>
            <a:ext cx="14744700" cy="8489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6877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9844844"/>
              </p:ext>
            </p:extLst>
          </p:nvPr>
        </p:nvGraphicFramePr>
        <p:xfrm>
          <a:off x="2" y="0"/>
          <a:ext cx="18000660" cy="14749421"/>
        </p:xfrm>
        <a:graphic>
          <a:graphicData uri="http://schemas.openxmlformats.org/drawingml/2006/table">
            <a:tbl>
              <a:tblPr firstRow="1" firstCol="1" bandRow="1"/>
              <a:tblGrid>
                <a:gridCol w="354623"/>
                <a:gridCol w="195796"/>
                <a:gridCol w="195796"/>
                <a:gridCol w="2990211"/>
                <a:gridCol w="1387365"/>
                <a:gridCol w="1182414"/>
                <a:gridCol w="1481959"/>
                <a:gridCol w="1844565"/>
                <a:gridCol w="1412258"/>
                <a:gridCol w="143559"/>
                <a:gridCol w="120726"/>
                <a:gridCol w="120726"/>
                <a:gridCol w="2430379"/>
                <a:gridCol w="2125855"/>
                <a:gridCol w="1483619"/>
                <a:gridCol w="168442"/>
                <a:gridCol w="120915"/>
                <a:gridCol w="120726"/>
                <a:gridCol w="120726"/>
              </a:tblGrid>
              <a:tr h="3786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865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048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111854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s-MX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s-MX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l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3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33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Na: 14.75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63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K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86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27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baseline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4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33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Cs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35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23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s-MX" sz="800" b="1" baseline="-250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37 </a:t>
                      </a:r>
                      <a:r>
                        <a:rPr lang="es-MX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63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32789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c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.5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5 -535 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Na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66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40-490 K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K: 11.24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 460-500 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: 8.5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 510 K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Cs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511 K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33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7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V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·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DME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1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3-378 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27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4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Mn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37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  <a:endParaRPr lang="es-MX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8-428 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1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3-423 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4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20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23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Mn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52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2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nZ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67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85K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800" b="1" kern="1200" baseline="-250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1-x)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22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1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800" b="1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: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10.35wt%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Na: 9.1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93</a:t>
                      </a:r>
                      <a:r>
                        <a:rPr lang="en-US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* and SBA-15 stabilized, 385K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K: 8.12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  <a:r>
                        <a:rPr lang="es-MX" sz="18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5 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: 9.51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00 </a:t>
                      </a: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Na:</a:t>
                      </a:r>
                      <a:r>
                        <a:rPr lang="en-US" sz="1800" b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84 </a:t>
                      </a:r>
                      <a:r>
                        <a:rPr lang="en-US" sz="1800" b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68 </a:t>
                      </a: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Zn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b="1" kern="1200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5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Zn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en-US" sz="1800" b="1" kern="1200" baseline="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=Mg 10.17 </a:t>
                      </a:r>
                      <a:r>
                        <a:rPr lang="en-US" sz="18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68-393 K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=</a:t>
                      </a:r>
                      <a:r>
                        <a:rPr lang="en-US" sz="18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9.67 </a:t>
                      </a:r>
                      <a:r>
                        <a:rPr lang="en-US" sz="18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85 K</a:t>
                      </a:r>
                    </a:p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1-x)</a:t>
                      </a:r>
                      <a:r>
                        <a:rPr lang="en-US" sz="1800" b="1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n</a:t>
                      </a:r>
                      <a:r>
                        <a:rPr lang="en-US" sz="1800" b="1" kern="1200" baseline="-250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5073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Li: 10.39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402 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: 9.42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</a:t>
                      </a:r>
                      <a:r>
                        <a:rPr lang="es-MX" sz="1800" b="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388 K</a:t>
                      </a:r>
                      <a:endParaRPr lang="es-MX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K: 8.61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3-493 K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Rb:</a:t>
                      </a:r>
                      <a:r>
                        <a:rPr lang="es-MX" sz="1800" b="1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9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530-544 K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=Cs:</a:t>
                      </a:r>
                      <a:r>
                        <a:rPr lang="es-MX" sz="1800" b="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5.74 </a:t>
                      </a:r>
                      <a:r>
                        <a:rPr lang="es-MX" sz="1800" b="0" baseline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523K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7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Y(BH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b="1" kern="12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b="0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 </a:t>
                      </a:r>
                      <a:r>
                        <a:rPr lang="en-US" sz="1800" b="0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1800" b="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 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7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9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533 K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Y(BH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s-MX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37 </a:t>
                      </a:r>
                      <a:r>
                        <a:rPr lang="es-MX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Zr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7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253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r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7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3-383 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Cd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38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Cd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7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53 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69 </a:t>
                      </a:r>
                      <a:r>
                        <a:rPr lang="es-MX" sz="18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(BH</a:t>
                      </a:r>
                      <a:r>
                        <a:rPr lang="en-US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45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358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3984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Hf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76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253 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Pb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s-MX" sz="18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800" b="1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14 </a:t>
                      </a:r>
                      <a:r>
                        <a:rPr lang="es-MX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s-MX" sz="18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360 </a:t>
                      </a:r>
                      <a:r>
                        <a:rPr lang="es-MX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  <a:tr h="2048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2A3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CC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1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7B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MX" sz="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63" marR="476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620545" y="7241778"/>
            <a:ext cx="184731" cy="653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28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620545" y="7241778"/>
            <a:ext cx="184731" cy="653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1942641"/>
              </p:ext>
            </p:extLst>
          </p:nvPr>
        </p:nvGraphicFramePr>
        <p:xfrm>
          <a:off x="171450" y="4275980"/>
          <a:ext cx="17657762" cy="2965798"/>
        </p:xfrm>
        <a:graphic>
          <a:graphicData uri="http://schemas.openxmlformats.org/drawingml/2006/table">
            <a:tbl>
              <a:tblPr firstRow="1" firstCol="1" bandRow="1"/>
              <a:tblGrid>
                <a:gridCol w="1809750"/>
                <a:gridCol w="2076450"/>
                <a:gridCol w="1409700"/>
                <a:gridCol w="228600"/>
                <a:gridCol w="228600"/>
                <a:gridCol w="1962150"/>
                <a:gridCol w="2133600"/>
                <a:gridCol w="2095500"/>
                <a:gridCol w="266700"/>
                <a:gridCol w="285750"/>
                <a:gridCol w="1276350"/>
                <a:gridCol w="1485900"/>
                <a:gridCol w="266700"/>
                <a:gridCol w="1566597"/>
                <a:gridCol w="565415"/>
              </a:tblGrid>
              <a:tr h="26723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La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29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01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14 </a:t>
                      </a:r>
                      <a:r>
                        <a:rPr lang="en-US" sz="1800" b="0" kern="1200" baseline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baseline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Ce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25 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, 523 K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97wt%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b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7 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11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Pr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22 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3 K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m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800" b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=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,Rb,Cs</a:t>
                      </a:r>
                      <a:endParaRPr lang="en-US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17, 4.31, 3.7 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553 K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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DME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s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7 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bEu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9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Gd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73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800" b="1" kern="1200" baseline="-250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d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+3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A=K, Cs</a:t>
                      </a:r>
                      <a:endParaRPr lang="en-US" sz="1800" kern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Ho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12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Er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kern="1200" baseline="-25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2 </a:t>
                      </a:r>
                      <a:r>
                        <a:rPr lang="en-US" sz="1800" b="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1 K</a:t>
                      </a:r>
                      <a:r>
                        <a:rPr lang="en-US" sz="18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es-MX" sz="1800" b="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Li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.74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a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.31 </a:t>
                      </a:r>
                      <a:r>
                        <a:rPr lang="en-US" sz="1800" b="0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b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err="1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KYb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(BH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800" b="1" baseline="-250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800" b="1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1800088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94 </a:t>
                      </a:r>
                      <a:r>
                        <a:rPr lang="en-US" sz="18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</a:tr>
              <a:tr h="2729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1805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46</TotalTime>
  <Words>722</Words>
  <Application>Microsoft Office PowerPoint</Application>
  <PresentationFormat>Personalizado</PresentationFormat>
  <Paragraphs>806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3" baseType="lpstr">
      <vt:lpstr>SimSun</vt:lpstr>
      <vt:lpstr>Arial</vt:lpstr>
      <vt:lpstr>Berlin Sans FB</vt:lpstr>
      <vt:lpstr>Calibri</vt:lpstr>
      <vt:lpstr>Calibri Light</vt:lpstr>
      <vt:lpstr>Symbol</vt:lpstr>
      <vt:lpstr>Times New Roman</vt:lpstr>
      <vt:lpstr>Tema de Office</vt:lpstr>
      <vt:lpstr>Metal borohydrides beyond group I and II, a review (supplementary material) Editable ¨periodic tables¨  Karina Suárez-Alcántara1* and Juan Rogelio Tena García1 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r. Karina</dc:creator>
  <cp:lastModifiedBy>Dr. Karina</cp:lastModifiedBy>
  <cp:revision>116</cp:revision>
  <dcterms:created xsi:type="dcterms:W3CDTF">2021-03-29T22:35:51Z</dcterms:created>
  <dcterms:modified xsi:type="dcterms:W3CDTF">2021-04-30T20:06:08Z</dcterms:modified>
</cp:coreProperties>
</file>